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72" r:id="rId1"/>
  </p:sldMasterIdLst>
  <p:sldIdLst>
    <p:sldId id="270" r:id="rId2"/>
    <p:sldId id="272" r:id="rId3"/>
    <p:sldId id="271" r:id="rId4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676" autoAdjust="0"/>
    <p:restoredTop sz="94660"/>
  </p:normalViewPr>
  <p:slideViewPr>
    <p:cSldViewPr snapToGrid="0">
      <p:cViewPr varScale="1">
        <p:scale>
          <a:sx n="79" d="100"/>
          <a:sy n="79" d="100"/>
        </p:scale>
        <p:origin x="350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51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8687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7014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3738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3347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8073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945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7672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826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9934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7797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6048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2A007-902E-4F24-BF3E-8A3ADDD05AA7}" type="datetimeFigureOut">
              <a:rPr kumimoji="1" lang="ja-JP" altLang="en-US" smtClean="0"/>
              <a:t>2023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F02FDC-142D-48EB-BD06-B3D421449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510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474097" y="14422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21D68AA6-D1FA-BEC3-45EB-A2CEEC80CDD0}"/>
              </a:ext>
            </a:extLst>
          </p:cNvPr>
          <p:cNvSpPr txBox="1"/>
          <p:nvPr/>
        </p:nvSpPr>
        <p:spPr>
          <a:xfrm>
            <a:off x="1474097" y="317235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2" name="図 291">
            <a:extLst>
              <a:ext uri="{FF2B5EF4-FFF2-40B4-BE49-F238E27FC236}">
                <a16:creationId xmlns:a16="http://schemas.microsoft.com/office/drawing/2014/main" id="{F8ACA449-087F-9DB6-FACC-A934FEF792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5759" y="298110"/>
            <a:ext cx="3350951" cy="2890256"/>
          </a:xfrm>
          <a:prstGeom prst="rect">
            <a:avLst/>
          </a:prstGeom>
        </p:spPr>
      </p:pic>
      <p:pic>
        <p:nvPicPr>
          <p:cNvPr id="294" name="図 293">
            <a:extLst>
              <a:ext uri="{FF2B5EF4-FFF2-40B4-BE49-F238E27FC236}">
                <a16:creationId xmlns:a16="http://schemas.microsoft.com/office/drawing/2014/main" id="{370648F3-E3B4-F729-C203-C1BB96F3AEE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lum bright="-33000" contrast="30000"/>
          </a:blip>
          <a:srcRect l="1" r="47595"/>
          <a:stretch/>
        </p:blipFill>
        <p:spPr>
          <a:xfrm>
            <a:off x="2261511" y="3420731"/>
            <a:ext cx="1187208" cy="1778859"/>
          </a:xfrm>
          <a:prstGeom prst="rect">
            <a:avLst/>
          </a:prstGeom>
        </p:spPr>
      </p:pic>
      <p:pic>
        <p:nvPicPr>
          <p:cNvPr id="295" name="図 294">
            <a:extLst>
              <a:ext uri="{FF2B5EF4-FFF2-40B4-BE49-F238E27FC236}">
                <a16:creationId xmlns:a16="http://schemas.microsoft.com/office/drawing/2014/main" id="{2B4D707F-C942-39C6-AF65-8270202EDDE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lum bright="-33000" contrast="30000"/>
          </a:blip>
          <a:srcRect l="46815" r="2002"/>
          <a:stretch/>
        </p:blipFill>
        <p:spPr>
          <a:xfrm>
            <a:off x="3826913" y="3420731"/>
            <a:ext cx="1159544" cy="1778859"/>
          </a:xfrm>
          <a:prstGeom prst="rect">
            <a:avLst/>
          </a:prstGeom>
        </p:spPr>
      </p:pic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id="{32252024-23B6-BA0A-A5CA-EEAC326FE694}"/>
              </a:ext>
            </a:extLst>
          </p:cNvPr>
          <p:cNvSpPr txBox="1"/>
          <p:nvPr/>
        </p:nvSpPr>
        <p:spPr>
          <a:xfrm>
            <a:off x="2740313" y="5197509"/>
            <a:ext cx="292388" cy="36163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テキスト ボックス 300">
            <a:extLst>
              <a:ext uri="{FF2B5EF4-FFF2-40B4-BE49-F238E27FC236}">
                <a16:creationId xmlns:a16="http://schemas.microsoft.com/office/drawing/2014/main" id="{C4E8CE53-AC9E-EEAD-C4CB-444D83724053}"/>
              </a:ext>
            </a:extLst>
          </p:cNvPr>
          <p:cNvSpPr txBox="1"/>
          <p:nvPr/>
        </p:nvSpPr>
        <p:spPr>
          <a:xfrm>
            <a:off x="2561353" y="5197509"/>
            <a:ext cx="292388" cy="30713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id="{56E3280D-0702-BB25-F962-EDA91933D7CF}"/>
              </a:ext>
            </a:extLst>
          </p:cNvPr>
          <p:cNvSpPr txBox="1"/>
          <p:nvPr/>
        </p:nvSpPr>
        <p:spPr>
          <a:xfrm>
            <a:off x="2916006" y="5197509"/>
            <a:ext cx="292388" cy="6197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4BE71B03-2564-5F54-AB10-C57D7D947E58}"/>
              </a:ext>
            </a:extLst>
          </p:cNvPr>
          <p:cNvSpPr txBox="1"/>
          <p:nvPr/>
        </p:nvSpPr>
        <p:spPr>
          <a:xfrm>
            <a:off x="3081560" y="5197509"/>
            <a:ext cx="292388" cy="6197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id="{730D6B9A-BE71-2EB1-49C4-0DEB1B942A5C}"/>
              </a:ext>
            </a:extLst>
          </p:cNvPr>
          <p:cNvSpPr txBox="1"/>
          <p:nvPr/>
        </p:nvSpPr>
        <p:spPr>
          <a:xfrm>
            <a:off x="3385535" y="4140938"/>
            <a:ext cx="510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</a:p>
          <a:p>
            <a:pPr algn="ctr"/>
            <a:r>
              <a:rPr lang="ja-JP" altLang="en-US" sz="600" dirty="0">
                <a:latin typeface="Arial" panose="020B0604020202020204" pitchFamily="34" charset="0"/>
                <a:cs typeface="Arial" panose="020B0604020202020204" pitchFamily="34" charset="0"/>
              </a:rPr>
              <a:t>◀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3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id="{81315652-398E-F227-2063-D549FE5BC1F5}"/>
              </a:ext>
            </a:extLst>
          </p:cNvPr>
          <p:cNvSpPr txBox="1"/>
          <p:nvPr/>
        </p:nvSpPr>
        <p:spPr>
          <a:xfrm>
            <a:off x="2572940" y="3229674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テキスト ボックス 305">
            <a:extLst>
              <a:ext uri="{FF2B5EF4-FFF2-40B4-BE49-F238E27FC236}">
                <a16:creationId xmlns:a16="http://schemas.microsoft.com/office/drawing/2014/main" id="{6ED315A8-D0A0-6AC0-341A-BCF61BBBE291}"/>
              </a:ext>
            </a:extLst>
          </p:cNvPr>
          <p:cNvSpPr txBox="1"/>
          <p:nvPr/>
        </p:nvSpPr>
        <p:spPr>
          <a:xfrm>
            <a:off x="4106585" y="3229674"/>
            <a:ext cx="5806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W199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8" name="図 307">
            <a:extLst>
              <a:ext uri="{FF2B5EF4-FFF2-40B4-BE49-F238E27FC236}">
                <a16:creationId xmlns:a16="http://schemas.microsoft.com/office/drawing/2014/main" id="{6B35AC61-3DF8-B800-3A19-4310CCB9815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" t="4263" r="47932" b="2562"/>
          <a:stretch/>
        </p:blipFill>
        <p:spPr>
          <a:xfrm>
            <a:off x="2299295" y="6063283"/>
            <a:ext cx="1149424" cy="1781566"/>
          </a:xfrm>
          <a:prstGeom prst="rect">
            <a:avLst/>
          </a:prstGeom>
        </p:spPr>
      </p:pic>
      <p:pic>
        <p:nvPicPr>
          <p:cNvPr id="309" name="図 308">
            <a:extLst>
              <a:ext uri="{FF2B5EF4-FFF2-40B4-BE49-F238E27FC236}">
                <a16:creationId xmlns:a16="http://schemas.microsoft.com/office/drawing/2014/main" id="{C5FE5C98-FB6E-2B0F-EF71-E3CD66A7AD6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8633" t="4263" b="2562"/>
          <a:stretch/>
        </p:blipFill>
        <p:spPr>
          <a:xfrm>
            <a:off x="3852542" y="6063283"/>
            <a:ext cx="1133915" cy="1781566"/>
          </a:xfrm>
          <a:prstGeom prst="rect">
            <a:avLst/>
          </a:prstGeom>
        </p:spPr>
      </p:pic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43F80195-BE75-7190-EE22-2BCAA741AAFA}"/>
              </a:ext>
            </a:extLst>
          </p:cNvPr>
          <p:cNvSpPr txBox="1"/>
          <p:nvPr/>
        </p:nvSpPr>
        <p:spPr>
          <a:xfrm>
            <a:off x="3385535" y="7002640"/>
            <a:ext cx="510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ja-JP" altLang="en-US" sz="600" dirty="0">
                <a:latin typeface="Arial" panose="020B0604020202020204" pitchFamily="34" charset="0"/>
                <a:cs typeface="Arial" panose="020B0604020202020204" pitchFamily="34" charset="0"/>
              </a:rPr>
              <a:t>◀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id="{F7A3F83F-C2C1-94D5-9A8E-7966A988D6D4}"/>
              </a:ext>
            </a:extLst>
          </p:cNvPr>
          <p:cNvSpPr txBox="1"/>
          <p:nvPr/>
        </p:nvSpPr>
        <p:spPr>
          <a:xfrm>
            <a:off x="4956534" y="6901789"/>
            <a:ext cx="479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ja-JP" altLang="en-US" sz="600" dirty="0">
                <a:latin typeface="Arial" panose="020B0604020202020204" pitchFamily="34" charset="0"/>
                <a:cs typeface="Arial" panose="020B0604020202020204" pitchFamily="34" charset="0"/>
              </a:rPr>
              <a:t>◀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B8EB0C03-C9DB-6BF2-6C3D-39B86332DF63}"/>
              </a:ext>
            </a:extLst>
          </p:cNvPr>
          <p:cNvSpPr txBox="1"/>
          <p:nvPr/>
        </p:nvSpPr>
        <p:spPr>
          <a:xfrm>
            <a:off x="4053558" y="5197509"/>
            <a:ext cx="292388" cy="36163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CF9CB802-C608-F54E-0BBA-5CC2082A3518}"/>
              </a:ext>
            </a:extLst>
          </p:cNvPr>
          <p:cNvSpPr txBox="1"/>
          <p:nvPr/>
        </p:nvSpPr>
        <p:spPr>
          <a:xfrm>
            <a:off x="3874598" y="5197509"/>
            <a:ext cx="292388" cy="30713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525541A1-52BC-D06F-40B8-F0CD7BF14DF3}"/>
              </a:ext>
            </a:extLst>
          </p:cNvPr>
          <p:cNvSpPr txBox="1"/>
          <p:nvPr/>
        </p:nvSpPr>
        <p:spPr>
          <a:xfrm>
            <a:off x="4229251" y="5197509"/>
            <a:ext cx="292388" cy="6197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B95D9D80-6160-FC38-C1B8-10C2B15DBB3F}"/>
              </a:ext>
            </a:extLst>
          </p:cNvPr>
          <p:cNvSpPr txBox="1"/>
          <p:nvPr/>
        </p:nvSpPr>
        <p:spPr>
          <a:xfrm>
            <a:off x="4394805" y="5197509"/>
            <a:ext cx="292388" cy="6197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A00E7DA7-FED0-EDA5-0BA1-946C10483A85}"/>
              </a:ext>
            </a:extLst>
          </p:cNvPr>
          <p:cNvSpPr txBox="1"/>
          <p:nvPr/>
        </p:nvSpPr>
        <p:spPr>
          <a:xfrm>
            <a:off x="2572940" y="5854410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B713796E-636F-A300-7124-819F3C347C76}"/>
              </a:ext>
            </a:extLst>
          </p:cNvPr>
          <p:cNvSpPr txBox="1"/>
          <p:nvPr/>
        </p:nvSpPr>
        <p:spPr>
          <a:xfrm>
            <a:off x="4106585" y="5854410"/>
            <a:ext cx="5806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W199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テキスト ボックス 327">
            <a:extLst>
              <a:ext uri="{FF2B5EF4-FFF2-40B4-BE49-F238E27FC236}">
                <a16:creationId xmlns:a16="http://schemas.microsoft.com/office/drawing/2014/main" id="{D04B7A35-2907-2F64-BDE1-16290D4E0294}"/>
              </a:ext>
            </a:extLst>
          </p:cNvPr>
          <p:cNvSpPr txBox="1"/>
          <p:nvPr/>
        </p:nvSpPr>
        <p:spPr>
          <a:xfrm>
            <a:off x="2751900" y="7844849"/>
            <a:ext cx="292388" cy="36163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id="{3BDA6BCC-F5F2-E5BB-15B5-94EB32E5602D}"/>
              </a:ext>
            </a:extLst>
          </p:cNvPr>
          <p:cNvSpPr txBox="1"/>
          <p:nvPr/>
        </p:nvSpPr>
        <p:spPr>
          <a:xfrm>
            <a:off x="2572940" y="7844849"/>
            <a:ext cx="292388" cy="30713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id="{BBAE8558-77C5-288B-D9DE-E5C053AE7EA5}"/>
              </a:ext>
            </a:extLst>
          </p:cNvPr>
          <p:cNvSpPr txBox="1"/>
          <p:nvPr/>
        </p:nvSpPr>
        <p:spPr>
          <a:xfrm>
            <a:off x="2927593" y="7844849"/>
            <a:ext cx="292388" cy="6197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18EC5FB1-40A8-B5F3-BCFC-AB9F9F3742FE}"/>
              </a:ext>
            </a:extLst>
          </p:cNvPr>
          <p:cNvSpPr txBox="1"/>
          <p:nvPr/>
        </p:nvSpPr>
        <p:spPr>
          <a:xfrm>
            <a:off x="3093147" y="7844849"/>
            <a:ext cx="292388" cy="6197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AC2C84C5-A0C1-7E6E-432C-D3266193DBC3}"/>
              </a:ext>
            </a:extLst>
          </p:cNvPr>
          <p:cNvSpPr txBox="1"/>
          <p:nvPr/>
        </p:nvSpPr>
        <p:spPr>
          <a:xfrm>
            <a:off x="4065145" y="7844849"/>
            <a:ext cx="292388" cy="36163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id="{B53A6E16-9EB1-3663-6672-52E4E7684C47}"/>
              </a:ext>
            </a:extLst>
          </p:cNvPr>
          <p:cNvSpPr txBox="1"/>
          <p:nvPr/>
        </p:nvSpPr>
        <p:spPr>
          <a:xfrm>
            <a:off x="3886185" y="7844849"/>
            <a:ext cx="292388" cy="30713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id="{A8764EBC-AE89-7CFF-2A06-2AFACCBDC591}"/>
              </a:ext>
            </a:extLst>
          </p:cNvPr>
          <p:cNvSpPr txBox="1"/>
          <p:nvPr/>
        </p:nvSpPr>
        <p:spPr>
          <a:xfrm>
            <a:off x="4240838" y="7844849"/>
            <a:ext cx="292388" cy="6197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テキスト ボックス 334">
            <a:extLst>
              <a:ext uri="{FF2B5EF4-FFF2-40B4-BE49-F238E27FC236}">
                <a16:creationId xmlns:a16="http://schemas.microsoft.com/office/drawing/2014/main" id="{AEC15AE0-BCBB-6460-F513-F98B92748DB0}"/>
              </a:ext>
            </a:extLst>
          </p:cNvPr>
          <p:cNvSpPr txBox="1"/>
          <p:nvPr/>
        </p:nvSpPr>
        <p:spPr>
          <a:xfrm>
            <a:off x="4406392" y="7844849"/>
            <a:ext cx="292388" cy="6197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id="{86E8EFAA-2B72-2E28-0A89-F930D5311178}"/>
              </a:ext>
            </a:extLst>
          </p:cNvPr>
          <p:cNvSpPr txBox="1"/>
          <p:nvPr/>
        </p:nvSpPr>
        <p:spPr>
          <a:xfrm>
            <a:off x="4925573" y="4075674"/>
            <a:ext cx="510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ORO1C</a:t>
            </a:r>
          </a:p>
          <a:p>
            <a:pPr algn="ctr"/>
            <a:r>
              <a:rPr lang="ja-JP" altLang="en-US" sz="600" dirty="0">
                <a:latin typeface="Arial" panose="020B0604020202020204" pitchFamily="34" charset="0"/>
                <a:cs typeface="Arial" panose="020B0604020202020204" pitchFamily="34" charset="0"/>
              </a:rPr>
              <a:t>◀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3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id="{ECC6DB44-EA70-BD5C-9D9B-25FA5713E8B3}"/>
              </a:ext>
            </a:extLst>
          </p:cNvPr>
          <p:cNvSpPr txBox="1"/>
          <p:nvPr/>
        </p:nvSpPr>
        <p:spPr>
          <a:xfrm>
            <a:off x="385902" y="8681125"/>
            <a:ext cx="6125633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: Effects of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O1C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nockdown by siRNAs in PDAC cell lines (PANC-1 and SW1990).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,B) Efficiency of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O1C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ockdown by si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O1C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and si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O1C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 according to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(A) and Western blotting (B). Expression of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O1C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and protein evaluated at 72 h after siRNA transfection.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SB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and GAPDH protein were used as the internal controls.</a:t>
            </a:r>
          </a:p>
        </p:txBody>
      </p:sp>
    </p:spTree>
    <p:extLst>
      <p:ext uri="{BB962C8B-B14F-4D97-AF65-F5344CB8AC3E}">
        <p14:creationId xmlns:p14="http://schemas.microsoft.com/office/powerpoint/2010/main" val="11322154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id="{ECC6DB44-EA70-BD5C-9D9B-25FA5713E8B3}"/>
              </a:ext>
            </a:extLst>
          </p:cNvPr>
          <p:cNvSpPr txBox="1"/>
          <p:nvPr/>
        </p:nvSpPr>
        <p:spPr>
          <a:xfrm>
            <a:off x="385902" y="7106325"/>
            <a:ext cx="6125633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:  The correlations of expression levels between five miRNAs (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6a-5p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9c-3p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30b-5p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48a-5p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17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O1C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ording to TCGA-PDAC data.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’s rank test indicated negative correlations of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6a-5p</a:t>
            </a:r>
            <a:r>
              <a:rPr lang="ja-JP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with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O1C.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28" name="図 427">
            <a:extLst>
              <a:ext uri="{FF2B5EF4-FFF2-40B4-BE49-F238E27FC236}">
                <a16:creationId xmlns:a16="http://schemas.microsoft.com/office/drawing/2014/main" id="{4545D188-8FB0-C0EB-8CE7-8A9A4703F2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602" y="2901652"/>
            <a:ext cx="6576977" cy="39345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97237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id="{ECC6DB44-EA70-BD5C-9D9B-25FA5713E8B3}"/>
              </a:ext>
            </a:extLst>
          </p:cNvPr>
          <p:cNvSpPr txBox="1"/>
          <p:nvPr/>
        </p:nvSpPr>
        <p:spPr>
          <a:xfrm>
            <a:off x="385902" y="8300125"/>
            <a:ext cx="6125633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: CORO1C protein expression in PDAC cells lines (PANC-1 and SW1990) by transfection of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6a-5p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9c-3p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30b-5p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48a-5p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17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sitometry analysis of bands by ImageJ software was shown. </a:t>
            </a: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030282FC-CA3E-0980-203D-26FFB12E7699}"/>
              </a:ext>
            </a:extLst>
          </p:cNvPr>
          <p:cNvGrpSpPr/>
          <p:nvPr/>
        </p:nvGrpSpPr>
        <p:grpSpPr>
          <a:xfrm>
            <a:off x="1632827" y="4432430"/>
            <a:ext cx="3608300" cy="3447644"/>
            <a:chOff x="6215382" y="1899511"/>
            <a:chExt cx="3608300" cy="3447644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DFF1716-3715-AFED-8522-B9BADA2F98F0}"/>
                </a:ext>
              </a:extLst>
            </p:cNvPr>
            <p:cNvSpPr txBox="1"/>
            <p:nvPr/>
          </p:nvSpPr>
          <p:spPr>
            <a:xfrm>
              <a:off x="8046608" y="1899511"/>
              <a:ext cx="70243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>
                  <a:latin typeface="Arial" panose="020B0604020202020204" pitchFamily="34" charset="0"/>
                  <a:cs typeface="Arial" panose="020B0604020202020204" pitchFamily="34" charset="0"/>
                </a:rPr>
                <a:t>SW1990</a:t>
              </a:r>
              <a:endPara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C859F0EE-F05D-E857-6025-CF055054426E}"/>
                </a:ext>
              </a:extLst>
            </p:cNvPr>
            <p:cNvGrpSpPr/>
            <p:nvPr/>
          </p:nvGrpSpPr>
          <p:grpSpPr>
            <a:xfrm>
              <a:off x="6215382" y="2187799"/>
              <a:ext cx="3608300" cy="3159356"/>
              <a:chOff x="6215382" y="2187799"/>
              <a:chExt cx="3608300" cy="3159356"/>
            </a:xfrm>
          </p:grpSpPr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005A9704-C18B-D029-FCB4-3799B6D673EE}"/>
                  </a:ext>
                </a:extLst>
              </p:cNvPr>
              <p:cNvSpPr txBox="1"/>
              <p:nvPr/>
            </p:nvSpPr>
            <p:spPr>
              <a:xfrm>
                <a:off x="6215382" y="2400227"/>
                <a:ext cx="492443" cy="2057546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RO1C/GAPDH</a:t>
                </a:r>
                <a:endParaRPr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relative to mock)</a:t>
                </a:r>
              </a:p>
            </p:txBody>
          </p:sp>
          <p:sp>
            <p:nvSpPr>
              <p:cNvPr id="8" name="Rectangle 4">
                <a:extLst>
                  <a:ext uri="{FF2B5EF4-FFF2-40B4-BE49-F238E27FC236}">
                    <a16:creationId xmlns:a16="http://schemas.microsoft.com/office/drawing/2014/main" id="{AB01BB23-3135-C5B1-BB2C-DDB9492B35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00529" y="2614722"/>
                <a:ext cx="252000" cy="485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5">
                <a:extLst>
                  <a:ext uri="{FF2B5EF4-FFF2-40B4-BE49-F238E27FC236}">
                    <a16:creationId xmlns:a16="http://schemas.microsoft.com/office/drawing/2014/main" id="{52BCFCDE-3049-51C6-0B5F-2DF2FB8E9B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00529" y="2614722"/>
                <a:ext cx="252000" cy="4856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Line 14">
                <a:extLst>
                  <a:ext uri="{FF2B5EF4-FFF2-40B4-BE49-F238E27FC236}">
                    <a16:creationId xmlns:a16="http://schemas.microsoft.com/office/drawing/2014/main" id="{1C1F2490-E0E0-E480-97C4-8FB3D3A11D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8403" y="4222120"/>
                <a:ext cx="7100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Line 15">
                <a:extLst>
                  <a:ext uri="{FF2B5EF4-FFF2-40B4-BE49-F238E27FC236}">
                    <a16:creationId xmlns:a16="http://schemas.microsoft.com/office/drawing/2014/main" id="{8B78B0E9-629C-E48C-586A-B896E3529D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8403" y="3876906"/>
                <a:ext cx="7100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Line 16">
                <a:extLst>
                  <a:ext uri="{FF2B5EF4-FFF2-40B4-BE49-F238E27FC236}">
                    <a16:creationId xmlns:a16="http://schemas.microsoft.com/office/drawing/2014/main" id="{D8915A57-2974-36D9-944C-479DC0B322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8403" y="3531691"/>
                <a:ext cx="7100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Line 17">
                <a:extLst>
                  <a:ext uri="{FF2B5EF4-FFF2-40B4-BE49-F238E27FC236}">
                    <a16:creationId xmlns:a16="http://schemas.microsoft.com/office/drawing/2014/main" id="{BC434DD0-4964-67B7-25F0-7F983C9C0E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8403" y="3180706"/>
                <a:ext cx="7100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Line 18">
                <a:extLst>
                  <a:ext uri="{FF2B5EF4-FFF2-40B4-BE49-F238E27FC236}">
                    <a16:creationId xmlns:a16="http://schemas.microsoft.com/office/drawing/2014/main" id="{715FC77D-BA8C-2FEB-4C60-7854D168B1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8403" y="2835491"/>
                <a:ext cx="7100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Rectangle 20">
                <a:extLst>
                  <a:ext uri="{FF2B5EF4-FFF2-40B4-BE49-F238E27FC236}">
                    <a16:creationId xmlns:a16="http://schemas.microsoft.com/office/drawing/2014/main" id="{F7550AF4-4313-DF70-3EC0-5DBF6C95B9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25465" y="4148218"/>
                <a:ext cx="24851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20</a:t>
                </a:r>
                <a:endParaRPr kumimoji="0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" name="Rectangle 21">
                <a:extLst>
                  <a:ext uri="{FF2B5EF4-FFF2-40B4-BE49-F238E27FC236}">
                    <a16:creationId xmlns:a16="http://schemas.microsoft.com/office/drawing/2014/main" id="{B1176268-A854-AFDE-EB6C-00938C2BCF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25465" y="3802970"/>
                <a:ext cx="24851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40</a:t>
                </a:r>
                <a:endParaRPr kumimoji="0" lang="ja-JP" altLang="ja-JP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" name="Rectangle 22">
                <a:extLst>
                  <a:ext uri="{FF2B5EF4-FFF2-40B4-BE49-F238E27FC236}">
                    <a16:creationId xmlns:a16="http://schemas.microsoft.com/office/drawing/2014/main" id="{385B4840-0BE5-B574-BAF6-E7A215E134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25465" y="3453477"/>
                <a:ext cx="24851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60</a:t>
                </a:r>
                <a:endParaRPr kumimoji="0" lang="ja-JP" altLang="ja-JP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" name="Rectangle 23">
                <a:extLst>
                  <a:ext uri="{FF2B5EF4-FFF2-40B4-BE49-F238E27FC236}">
                    <a16:creationId xmlns:a16="http://schemas.microsoft.com/office/drawing/2014/main" id="{05D78292-2B75-EB28-5B3D-BAC686AAAF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25465" y="3105502"/>
                <a:ext cx="24851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80</a:t>
                </a:r>
                <a:endParaRPr kumimoji="0" lang="ja-JP" altLang="ja-JP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" name="Rectangle 24">
                <a:extLst>
                  <a:ext uri="{FF2B5EF4-FFF2-40B4-BE49-F238E27FC236}">
                    <a16:creationId xmlns:a16="http://schemas.microsoft.com/office/drawing/2014/main" id="{7A1F6895-8E43-4E10-E1B0-52226F5160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25465" y="2756405"/>
                <a:ext cx="24851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100</a:t>
                </a:r>
                <a:endParaRPr kumimoji="0" lang="ja-JP" altLang="ja-JP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1EC85C8D-43CB-3FE9-532E-59DE10104F8E}"/>
                  </a:ext>
                </a:extLst>
              </p:cNvPr>
              <p:cNvSpPr txBox="1"/>
              <p:nvPr/>
            </p:nvSpPr>
            <p:spPr>
              <a:xfrm>
                <a:off x="7482724" y="4587973"/>
                <a:ext cx="323165" cy="43858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0883A0F0-ED83-4DDF-473C-E398564B2795}"/>
                  </a:ext>
                </a:extLst>
              </p:cNvPr>
              <p:cNvSpPr txBox="1"/>
              <p:nvPr/>
            </p:nvSpPr>
            <p:spPr>
              <a:xfrm>
                <a:off x="7111606" y="4587973"/>
                <a:ext cx="323165" cy="368049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5589127D-8E9A-AFC4-732D-F1CEEE02AD78}"/>
                  </a:ext>
                </a:extLst>
              </p:cNvPr>
              <p:cNvSpPr txBox="1"/>
              <p:nvPr/>
            </p:nvSpPr>
            <p:spPr>
              <a:xfrm>
                <a:off x="7857957" y="4587973"/>
                <a:ext cx="323165" cy="69506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kumimoji="1" lang="en-US" altLang="ja-JP" sz="900" i="1">
                    <a:latin typeface="Arial" panose="020B0604020202020204" pitchFamily="34" charset="0"/>
                    <a:cs typeface="Arial" panose="020B0604020202020204" pitchFamily="34" charset="0"/>
                  </a:rPr>
                  <a:t>miR-26a-5p</a:t>
                </a:r>
                <a:endParaRPr kumimoji="1" lang="ja-JP" altLang="en-US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5DB4F66B-F937-9A05-D44B-5C8C29587D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82921" y="2249354"/>
                <a:ext cx="0" cy="2312759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" name="Line 18">
                <a:extLst>
                  <a:ext uri="{FF2B5EF4-FFF2-40B4-BE49-F238E27FC236}">
                    <a16:creationId xmlns:a16="http://schemas.microsoft.com/office/drawing/2014/main" id="{FBF6EDEF-C6B5-7B54-8754-B316D768C9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13483" y="2490051"/>
                <a:ext cx="7100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96513E36-81C2-A6A0-7C3E-C8F0455D9D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25465" y="2410475"/>
                <a:ext cx="24851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1</a:t>
                </a:r>
                <a:r>
                  <a:rPr kumimoji="0" lang="en-US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2</a:t>
                </a: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" name="Rectangle 24">
                <a:extLst>
                  <a:ext uri="{FF2B5EF4-FFF2-40B4-BE49-F238E27FC236}">
                    <a16:creationId xmlns:a16="http://schemas.microsoft.com/office/drawing/2014/main" id="{BC62A670-0281-0588-AB41-9DDFAEFD7F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38864" y="2187799"/>
                <a:ext cx="24851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(%)</a:t>
                </a:r>
                <a:endParaRPr kumimoji="0" lang="ja-JP" altLang="ja-JP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" name="Line 13">
                <a:extLst>
                  <a:ext uri="{FF2B5EF4-FFF2-40B4-BE49-F238E27FC236}">
                    <a16:creationId xmlns:a16="http://schemas.microsoft.com/office/drawing/2014/main" id="{858E94FC-B391-5576-B34A-B355D41AE5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8403" y="4562787"/>
                <a:ext cx="7100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Rectangle 19">
                <a:extLst>
                  <a:ext uri="{FF2B5EF4-FFF2-40B4-BE49-F238E27FC236}">
                    <a16:creationId xmlns:a16="http://schemas.microsoft.com/office/drawing/2014/main" id="{CF35A8B1-6976-6207-EF2A-F64A60AB4C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25465" y="4486607"/>
                <a:ext cx="24851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メイリオ" panose="020B0604030504040204" pitchFamily="50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29" name="グループ化 28">
                <a:extLst>
                  <a:ext uri="{FF2B5EF4-FFF2-40B4-BE49-F238E27FC236}">
                    <a16:creationId xmlns:a16="http://schemas.microsoft.com/office/drawing/2014/main" id="{F64A7C20-A533-E227-659A-E16BF6DE7310}"/>
                  </a:ext>
                </a:extLst>
              </p:cNvPr>
              <p:cNvGrpSpPr/>
              <p:nvPr/>
            </p:nvGrpSpPr>
            <p:grpSpPr>
              <a:xfrm>
                <a:off x="7135340" y="2819635"/>
                <a:ext cx="2508033" cy="1743152"/>
                <a:chOff x="7161467" y="2819635"/>
                <a:chExt cx="2508033" cy="1743152"/>
              </a:xfrm>
            </p:grpSpPr>
            <p:sp>
              <p:nvSpPr>
                <p:cNvPr id="35" name="Rectangle 30">
                  <a:extLst>
                    <a:ext uri="{FF2B5EF4-FFF2-40B4-BE49-F238E27FC236}">
                      <a16:creationId xmlns:a16="http://schemas.microsoft.com/office/drawing/2014/main" id="{ED20D82E-6977-348A-7DD5-EE0C5F27B1D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61467" y="2835491"/>
                  <a:ext cx="274273" cy="1727296"/>
                </a:xfrm>
                <a:prstGeom prst="rect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6" name="Rectangle 31">
                  <a:extLst>
                    <a:ext uri="{FF2B5EF4-FFF2-40B4-BE49-F238E27FC236}">
                      <a16:creationId xmlns:a16="http://schemas.microsoft.com/office/drawing/2014/main" id="{14767053-629C-69DC-25F0-FAE2D701F6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528086" y="2819635"/>
                  <a:ext cx="275509" cy="1743152"/>
                </a:xfrm>
                <a:prstGeom prst="rect">
                  <a:avLst/>
                </a:prstGeom>
                <a:solidFill>
                  <a:schemeClr val="accent3">
                    <a:lumMod val="40000"/>
                    <a:lumOff val="60000"/>
                  </a:schemeClr>
                </a:solidFill>
                <a:ln w="1270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7" name="Rectangle 32">
                  <a:extLst>
                    <a:ext uri="{FF2B5EF4-FFF2-40B4-BE49-F238E27FC236}">
                      <a16:creationId xmlns:a16="http://schemas.microsoft.com/office/drawing/2014/main" id="{B1EC2141-C609-1123-F2EA-98E23515CEF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896299" y="3211355"/>
                  <a:ext cx="274273" cy="1351432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8" name="Rectangle 33">
                  <a:extLst>
                    <a:ext uri="{FF2B5EF4-FFF2-40B4-BE49-F238E27FC236}">
                      <a16:creationId xmlns:a16="http://schemas.microsoft.com/office/drawing/2014/main" id="{73015ED6-121D-A9BC-A963-F7CE0F5E1B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270784" y="3772819"/>
                  <a:ext cx="275509" cy="789968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" name="Rectangle 34">
                  <a:extLst>
                    <a:ext uri="{FF2B5EF4-FFF2-40B4-BE49-F238E27FC236}">
                      <a16:creationId xmlns:a16="http://schemas.microsoft.com/office/drawing/2014/main" id="{A827BCD3-CC20-6098-85FE-AABB79AB534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45145" y="2889586"/>
                  <a:ext cx="274273" cy="1673201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" name="Rectangle 35">
                  <a:extLst>
                    <a:ext uri="{FF2B5EF4-FFF2-40B4-BE49-F238E27FC236}">
                      <a16:creationId xmlns:a16="http://schemas.microsoft.com/office/drawing/2014/main" id="{CD6189F6-4204-D73C-3F4F-3D30ADA72D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018098" y="3354053"/>
                  <a:ext cx="274273" cy="1208734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" name="Rectangle 36">
                  <a:extLst>
                    <a:ext uri="{FF2B5EF4-FFF2-40B4-BE49-F238E27FC236}">
                      <a16:creationId xmlns:a16="http://schemas.microsoft.com/office/drawing/2014/main" id="{FB67D342-423B-B92B-7DAB-2A541AE0243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393991" y="3681418"/>
                  <a:ext cx="275509" cy="881369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B9C2A9BA-4C3E-F79A-2011-FBC9B6E45F12}"/>
                  </a:ext>
                </a:extLst>
              </p:cNvPr>
              <p:cNvSpPr txBox="1"/>
              <p:nvPr/>
            </p:nvSpPr>
            <p:spPr>
              <a:xfrm>
                <a:off x="8228079" y="4587973"/>
                <a:ext cx="323165" cy="68865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3AD8A9E7-ABB4-3751-0BC7-4D81540F7341}"/>
                  </a:ext>
                </a:extLst>
              </p:cNvPr>
              <p:cNvSpPr txBox="1"/>
              <p:nvPr/>
            </p:nvSpPr>
            <p:spPr>
              <a:xfrm>
                <a:off x="8981370" y="4587973"/>
                <a:ext cx="323165" cy="75918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148a-5p</a:t>
                </a:r>
                <a:endParaRPr kumimoji="1" lang="ja-JP" altLang="en-US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3838B0F5-3DB7-9B7E-F59E-F48A81EC68EF}"/>
                  </a:ext>
                </a:extLst>
              </p:cNvPr>
              <p:cNvSpPr txBox="1"/>
              <p:nvPr/>
            </p:nvSpPr>
            <p:spPr>
              <a:xfrm>
                <a:off x="8602547" y="4587973"/>
                <a:ext cx="323165" cy="75918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130b-5p</a:t>
                </a:r>
                <a:endParaRPr kumimoji="1" lang="ja-JP" altLang="en-US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BFDDEB99-250D-BE10-1D39-5448E21A2444}"/>
                  </a:ext>
                </a:extLst>
              </p:cNvPr>
              <p:cNvSpPr txBox="1"/>
              <p:nvPr/>
            </p:nvSpPr>
            <p:spPr>
              <a:xfrm>
                <a:off x="9353420" y="4587973"/>
                <a:ext cx="323165" cy="528350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r"/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17</a:t>
                </a:r>
                <a:endParaRPr kumimoji="1" lang="ja-JP" altLang="en-US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id="{7FD34335-4279-CE1F-1610-4D8554ECD5E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71971" y="4561725"/>
                <a:ext cx="2851711" cy="1062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957D7258-2E82-69A0-DD3A-BF6479517FB9}"/>
              </a:ext>
            </a:extLst>
          </p:cNvPr>
          <p:cNvGrpSpPr/>
          <p:nvPr/>
        </p:nvGrpSpPr>
        <p:grpSpPr>
          <a:xfrm>
            <a:off x="1635495" y="744997"/>
            <a:ext cx="3608300" cy="3469412"/>
            <a:chOff x="1264547" y="1899511"/>
            <a:chExt cx="3608300" cy="3469412"/>
          </a:xfrm>
        </p:grpSpPr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AB195692-9AAA-3A10-77CB-F7A5562A567D}"/>
                </a:ext>
              </a:extLst>
            </p:cNvPr>
            <p:cNvSpPr txBox="1"/>
            <p:nvPr/>
          </p:nvSpPr>
          <p:spPr>
            <a:xfrm>
              <a:off x="1264547" y="2421995"/>
              <a:ext cx="492443" cy="2057546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ORO1C/GAPDH</a:t>
              </a:r>
              <a:endPara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</a:p>
          </p:txBody>
        </p:sp>
        <p:sp>
          <p:nvSpPr>
            <p:cNvPr id="44" name="Rectangle 4">
              <a:extLst>
                <a:ext uri="{FF2B5EF4-FFF2-40B4-BE49-F238E27FC236}">
                  <a16:creationId xmlns:a16="http://schemas.microsoft.com/office/drawing/2014/main" id="{0A42061D-3946-F5FF-7C0F-9761B857BF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694" y="2636490"/>
              <a:ext cx="252000" cy="485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5">
              <a:extLst>
                <a:ext uri="{FF2B5EF4-FFF2-40B4-BE49-F238E27FC236}">
                  <a16:creationId xmlns:a16="http://schemas.microsoft.com/office/drawing/2014/main" id="{892E2627-40B5-9857-F5E8-4B9527448E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694" y="2636490"/>
              <a:ext cx="252000" cy="4856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Line 14">
              <a:extLst>
                <a:ext uri="{FF2B5EF4-FFF2-40B4-BE49-F238E27FC236}">
                  <a16:creationId xmlns:a16="http://schemas.microsoft.com/office/drawing/2014/main" id="{FA65F07B-D53E-4647-4A81-8399E82BF4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7568" y="4243888"/>
              <a:ext cx="71005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Line 15">
              <a:extLst>
                <a:ext uri="{FF2B5EF4-FFF2-40B4-BE49-F238E27FC236}">
                  <a16:creationId xmlns:a16="http://schemas.microsoft.com/office/drawing/2014/main" id="{81B62987-7964-7333-1985-156380E024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7568" y="3898674"/>
              <a:ext cx="71005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Line 16">
              <a:extLst>
                <a:ext uri="{FF2B5EF4-FFF2-40B4-BE49-F238E27FC236}">
                  <a16:creationId xmlns:a16="http://schemas.microsoft.com/office/drawing/2014/main" id="{3B0F4664-D2F3-47FC-6209-3A9F603742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7568" y="3553459"/>
              <a:ext cx="71005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Line 17">
              <a:extLst>
                <a:ext uri="{FF2B5EF4-FFF2-40B4-BE49-F238E27FC236}">
                  <a16:creationId xmlns:a16="http://schemas.microsoft.com/office/drawing/2014/main" id="{7CF25083-4B69-D844-0659-9E549843A7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7568" y="3202474"/>
              <a:ext cx="71005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Line 18">
              <a:extLst>
                <a:ext uri="{FF2B5EF4-FFF2-40B4-BE49-F238E27FC236}">
                  <a16:creationId xmlns:a16="http://schemas.microsoft.com/office/drawing/2014/main" id="{0E356A5C-B863-A145-93C5-3D98D60FB0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7568" y="2857259"/>
              <a:ext cx="71005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20">
              <a:extLst>
                <a:ext uri="{FF2B5EF4-FFF2-40B4-BE49-F238E27FC236}">
                  <a16:creationId xmlns:a16="http://schemas.microsoft.com/office/drawing/2014/main" id="{1C584DF4-2BC3-98E5-EDB1-5C525C5EB9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4630" y="4169986"/>
              <a:ext cx="2485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20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" name="Rectangle 21">
              <a:extLst>
                <a:ext uri="{FF2B5EF4-FFF2-40B4-BE49-F238E27FC236}">
                  <a16:creationId xmlns:a16="http://schemas.microsoft.com/office/drawing/2014/main" id="{6A8B56FB-77E8-D50F-4744-1E901E28A2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4630" y="3824738"/>
              <a:ext cx="2485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4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" name="Rectangle 22">
              <a:extLst>
                <a:ext uri="{FF2B5EF4-FFF2-40B4-BE49-F238E27FC236}">
                  <a16:creationId xmlns:a16="http://schemas.microsoft.com/office/drawing/2014/main" id="{BCCB17FF-54A6-B96D-D74F-E1D9C3348D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4630" y="3475245"/>
              <a:ext cx="2485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6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4" name="Rectangle 23">
              <a:extLst>
                <a:ext uri="{FF2B5EF4-FFF2-40B4-BE49-F238E27FC236}">
                  <a16:creationId xmlns:a16="http://schemas.microsoft.com/office/drawing/2014/main" id="{FF4EB835-BDCA-3B81-15B9-7EE48BFCC1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4630" y="3127270"/>
              <a:ext cx="2485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8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5" name="Rectangle 24">
              <a:extLst>
                <a:ext uri="{FF2B5EF4-FFF2-40B4-BE49-F238E27FC236}">
                  <a16:creationId xmlns:a16="http://schemas.microsoft.com/office/drawing/2014/main" id="{9F2B9187-0AA9-67CF-51A6-1440AC209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4630" y="2778173"/>
              <a:ext cx="2485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10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89FDF4F0-42A0-2146-3B37-D7B315247C44}"/>
                </a:ext>
              </a:extLst>
            </p:cNvPr>
            <p:cNvSpPr txBox="1"/>
            <p:nvPr/>
          </p:nvSpPr>
          <p:spPr>
            <a:xfrm>
              <a:off x="2531889" y="4609741"/>
              <a:ext cx="323165" cy="43858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337CE6DE-8A3E-5B19-35F5-BB1C5FF8AA50}"/>
                </a:ext>
              </a:extLst>
            </p:cNvPr>
            <p:cNvSpPr txBox="1"/>
            <p:nvPr/>
          </p:nvSpPr>
          <p:spPr>
            <a:xfrm>
              <a:off x="2160771" y="4609741"/>
              <a:ext cx="323165" cy="3680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13B5A92B-A818-7DB0-1494-222D843B4BFC}"/>
                </a:ext>
              </a:extLst>
            </p:cNvPr>
            <p:cNvSpPr txBox="1"/>
            <p:nvPr/>
          </p:nvSpPr>
          <p:spPr>
            <a:xfrm>
              <a:off x="2907122" y="4609741"/>
              <a:ext cx="323165" cy="69506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kumimoji="1" lang="en-US" altLang="ja-JP" sz="900" i="1">
                  <a:latin typeface="Arial" panose="020B0604020202020204" pitchFamily="34" charset="0"/>
                  <a:cs typeface="Arial" panose="020B0604020202020204" pitchFamily="34" charset="0"/>
                </a:rPr>
                <a:t>miR-26a-5p</a:t>
              </a:r>
              <a:endParaRPr kumimoji="1" lang="ja-JP" altLang="en-US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A0012FC9-341D-6F82-ADE4-89C061BF5CE2}"/>
                </a:ext>
              </a:extLst>
            </p:cNvPr>
            <p:cNvCxnSpPr>
              <a:cxnSpLocks/>
            </p:cNvCxnSpPr>
            <p:nvPr/>
          </p:nvCxnSpPr>
          <p:spPr>
            <a:xfrm>
              <a:off x="2032086" y="2271122"/>
              <a:ext cx="0" cy="2312759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0" name="Line 18">
              <a:extLst>
                <a:ext uri="{FF2B5EF4-FFF2-40B4-BE49-F238E27FC236}">
                  <a16:creationId xmlns:a16="http://schemas.microsoft.com/office/drawing/2014/main" id="{77091D37-7A6D-9EE2-826B-4C82674056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62648" y="2511819"/>
              <a:ext cx="71005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24">
              <a:extLst>
                <a:ext uri="{FF2B5EF4-FFF2-40B4-BE49-F238E27FC236}">
                  <a16:creationId xmlns:a16="http://schemas.microsoft.com/office/drawing/2014/main" id="{4DF965A3-A4A4-0BA2-814B-BCB09B0CFE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4630" y="2432243"/>
              <a:ext cx="2485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1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2</a:t>
              </a: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2" name="Rectangle 24">
              <a:extLst>
                <a:ext uri="{FF2B5EF4-FFF2-40B4-BE49-F238E27FC236}">
                  <a16:creationId xmlns:a16="http://schemas.microsoft.com/office/drawing/2014/main" id="{4CEEC328-5B4A-45B4-8972-0C7EF28967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8029" y="2209567"/>
              <a:ext cx="2485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(%)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3" name="Line 13">
              <a:extLst>
                <a:ext uri="{FF2B5EF4-FFF2-40B4-BE49-F238E27FC236}">
                  <a16:creationId xmlns:a16="http://schemas.microsoft.com/office/drawing/2014/main" id="{09E766CA-5460-6198-6424-696002F8D6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7568" y="4584555"/>
              <a:ext cx="71005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Rectangle 19">
              <a:extLst>
                <a:ext uri="{FF2B5EF4-FFF2-40B4-BE49-F238E27FC236}">
                  <a16:creationId xmlns:a16="http://schemas.microsoft.com/office/drawing/2014/main" id="{96A3597E-F702-FE7A-5B50-8FD640142A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4630" y="4508375"/>
              <a:ext cx="2485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46D8DD85-2A4A-4579-BAE8-346055DBC753}"/>
                </a:ext>
              </a:extLst>
            </p:cNvPr>
            <p:cNvSpPr txBox="1"/>
            <p:nvPr/>
          </p:nvSpPr>
          <p:spPr>
            <a:xfrm>
              <a:off x="3277244" y="4609741"/>
              <a:ext cx="323165" cy="688651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miR-29c-3p</a:t>
              </a:r>
              <a:endParaRPr kumimoji="1" lang="ja-JP" altLang="en-US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id="{746F412D-6F4D-4A9A-F9DF-6F9C45A8C3FB}"/>
                </a:ext>
              </a:extLst>
            </p:cNvPr>
            <p:cNvSpPr txBox="1"/>
            <p:nvPr/>
          </p:nvSpPr>
          <p:spPr>
            <a:xfrm>
              <a:off x="4030535" y="4609741"/>
              <a:ext cx="323165" cy="75918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miR-148a-5p</a:t>
              </a:r>
              <a:endParaRPr kumimoji="1" lang="ja-JP" altLang="en-US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B776B355-E80F-161B-7CE6-3BFFB2C6F0AF}"/>
                </a:ext>
              </a:extLst>
            </p:cNvPr>
            <p:cNvSpPr txBox="1"/>
            <p:nvPr/>
          </p:nvSpPr>
          <p:spPr>
            <a:xfrm>
              <a:off x="3651712" y="4609741"/>
              <a:ext cx="323165" cy="75918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miR-130b-5p</a:t>
              </a:r>
              <a:endParaRPr kumimoji="1" lang="ja-JP" altLang="en-US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テキスト ボックス 195">
              <a:extLst>
                <a:ext uri="{FF2B5EF4-FFF2-40B4-BE49-F238E27FC236}">
                  <a16:creationId xmlns:a16="http://schemas.microsoft.com/office/drawing/2014/main" id="{CF38CC04-3DB7-C1B9-8005-C9D352DDC0B2}"/>
                </a:ext>
              </a:extLst>
            </p:cNvPr>
            <p:cNvSpPr txBox="1"/>
            <p:nvPr/>
          </p:nvSpPr>
          <p:spPr>
            <a:xfrm>
              <a:off x="4402585" y="4609741"/>
              <a:ext cx="323165" cy="52835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r"/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miR-217</a:t>
              </a:r>
              <a:endParaRPr kumimoji="1" lang="ja-JP" altLang="en-US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Rectangle 83">
              <a:extLst>
                <a:ext uri="{FF2B5EF4-FFF2-40B4-BE49-F238E27FC236}">
                  <a16:creationId xmlns:a16="http://schemas.microsoft.com/office/drawing/2014/main" id="{9E810340-3E3D-3719-FA8C-D07F099E23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8092" y="2857259"/>
              <a:ext cx="273600" cy="1727296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" name="Rectangle 84">
              <a:extLst>
                <a:ext uri="{FF2B5EF4-FFF2-40B4-BE49-F238E27FC236}">
                  <a16:creationId xmlns:a16="http://schemas.microsoft.com/office/drawing/2014/main" id="{4F809E26-A5BE-5C26-E1A3-9944FA2AF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945" y="2709341"/>
              <a:ext cx="273600" cy="1875214"/>
            </a:xfrm>
            <a:prstGeom prst="rect">
              <a:avLst/>
            </a:prstGeom>
            <a:solidFill>
              <a:schemeClr val="accent3">
                <a:lumMod val="40000"/>
                <a:lumOff val="60000"/>
              </a:schemeClr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199" name="Rectangle 85">
              <a:extLst>
                <a:ext uri="{FF2B5EF4-FFF2-40B4-BE49-F238E27FC236}">
                  <a16:creationId xmlns:a16="http://schemas.microsoft.com/office/drawing/2014/main" id="{B205268E-25F3-A5DA-DD4E-C940D35B70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9229" y="3993839"/>
              <a:ext cx="273600" cy="590716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" name="Rectangle 86">
              <a:extLst>
                <a:ext uri="{FF2B5EF4-FFF2-40B4-BE49-F238E27FC236}">
                  <a16:creationId xmlns:a16="http://schemas.microsoft.com/office/drawing/2014/main" id="{E311A8F9-8AA5-6BDF-0506-9012AC13F5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2672" y="4171339"/>
              <a:ext cx="273600" cy="413215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" name="Rectangle 87">
              <a:extLst>
                <a:ext uri="{FF2B5EF4-FFF2-40B4-BE49-F238E27FC236}">
                  <a16:creationId xmlns:a16="http://schemas.microsoft.com/office/drawing/2014/main" id="{8F485B8E-EA85-0942-6F9A-E888E7829D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1945" y="3321051"/>
              <a:ext cx="273600" cy="1263503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" name="Rectangle 88">
              <a:extLst>
                <a:ext uri="{FF2B5EF4-FFF2-40B4-BE49-F238E27FC236}">
                  <a16:creationId xmlns:a16="http://schemas.microsoft.com/office/drawing/2014/main" id="{9CABED9A-3F42-D852-ADDC-DB3CB5AAB4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1220" y="3780074"/>
              <a:ext cx="273600" cy="804481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" name="Rectangle 89">
              <a:extLst>
                <a:ext uri="{FF2B5EF4-FFF2-40B4-BE49-F238E27FC236}">
                  <a16:creationId xmlns:a16="http://schemas.microsoft.com/office/drawing/2014/main" id="{EC5FA61B-2D8D-A520-4F79-FC922873DA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3379" y="3996701"/>
              <a:ext cx="273600" cy="587853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cxnSp>
          <p:nvCxnSpPr>
            <p:cNvPr id="204" name="直線コネクタ 203">
              <a:extLst>
                <a:ext uri="{FF2B5EF4-FFF2-40B4-BE49-F238E27FC236}">
                  <a16:creationId xmlns:a16="http://schemas.microsoft.com/office/drawing/2014/main" id="{5B9F7EBC-C724-4BBE-6C41-D30774988CD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21136" y="4583493"/>
              <a:ext cx="2851711" cy="1062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FFB3A3F6-96D1-08C0-77C3-E7F24551169B}"/>
                </a:ext>
              </a:extLst>
            </p:cNvPr>
            <p:cNvSpPr txBox="1"/>
            <p:nvPr/>
          </p:nvSpPr>
          <p:spPr>
            <a:xfrm>
              <a:off x="3098829" y="1899511"/>
              <a:ext cx="67999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>
                  <a:latin typeface="Arial" panose="020B0604020202020204" pitchFamily="34" charset="0"/>
                  <a:cs typeface="Arial" panose="020B0604020202020204" pitchFamily="34" charset="0"/>
                </a:rPr>
                <a:t>PANC-1</a:t>
              </a:r>
              <a:endPara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0343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1</Words>
  <Application>Microsoft Office PowerPoint</Application>
  <PresentationFormat>A4 Paper (210x297 mm)</PresentationFormat>
  <Paragraphs>7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3-03-14T15:05:25Z</dcterms:created>
  <dcterms:modified xsi:type="dcterms:W3CDTF">2023-04-28T02:51:22Z</dcterms:modified>
</cp:coreProperties>
</file>